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61" r:id="rId3"/>
    <p:sldId id="259" r:id="rId4"/>
    <p:sldId id="258" r:id="rId5"/>
    <p:sldId id="263" r:id="rId6"/>
    <p:sldId id="260" r:id="rId7"/>
    <p:sldId id="262" r:id="rId8"/>
    <p:sldId id="257" r:id="rId9"/>
    <p:sldId id="264" r:id="rId10"/>
    <p:sldId id="265" r:id="rId11"/>
  </p:sldIdLst>
  <p:sldSz cx="12801600" cy="9601200" type="A3"/>
  <p:notesSz cx="6858000" cy="9144000"/>
  <p:defaultTextStyle>
    <a:defPPr>
      <a:defRPr lang="zh-CN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00"/>
    <p:restoredTop sz="96341"/>
  </p:normalViewPr>
  <p:slideViewPr>
    <p:cSldViewPr snapToGrid="0" snapToObjects="1">
      <p:cViewPr varScale="1">
        <p:scale>
          <a:sx n="80" d="100"/>
          <a:sy n="80" d="100"/>
        </p:scale>
        <p:origin x="4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634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0014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7582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83220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03537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38678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57210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94373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92297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246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45307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50BB0-64A2-144D-8764-34E607F0E9C5}" type="datetimeFigureOut">
              <a:rPr kumimoji="1" lang="zh-CN" altLang="en-US" smtClean="0"/>
              <a:t>2020/4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987E7-2A2B-9742-8AB2-642FA19105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8614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6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9.png"/><Relationship Id="rId2" Type="http://schemas.openxmlformats.org/officeDocument/2006/relationships/image" Target="../media/image2.png"/><Relationship Id="rId16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21.png"/><Relationship Id="rId2" Type="http://schemas.openxmlformats.org/officeDocument/2006/relationships/image" Target="../media/image20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23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26.png"/><Relationship Id="rId2" Type="http://schemas.openxmlformats.org/officeDocument/2006/relationships/image" Target="../media/image2.png"/><Relationship Id="rId16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27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172AB874-1695-DB4F-9340-8FDA374C51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4567" y="2281884"/>
            <a:ext cx="7480300" cy="3556000"/>
          </a:xfrm>
          <a:prstGeom prst="rect">
            <a:avLst/>
          </a:prstGeom>
        </p:spPr>
      </p:pic>
      <p:grpSp>
        <p:nvGrpSpPr>
          <p:cNvPr id="36" name="组合 35">
            <a:extLst>
              <a:ext uri="{FF2B5EF4-FFF2-40B4-BE49-F238E27FC236}">
                <a16:creationId xmlns:a16="http://schemas.microsoft.com/office/drawing/2014/main" id="{D524EF30-DA80-C743-A1A4-3A51DD147FF5}"/>
              </a:ext>
            </a:extLst>
          </p:cNvPr>
          <p:cNvGrpSpPr/>
          <p:nvPr/>
        </p:nvGrpSpPr>
        <p:grpSpPr>
          <a:xfrm>
            <a:off x="506055" y="1230660"/>
            <a:ext cx="2537784" cy="5190493"/>
            <a:chOff x="1851343" y="1128291"/>
            <a:chExt cx="2537784" cy="5190493"/>
          </a:xfrm>
        </p:grpSpPr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9DB48EEB-60E1-494E-9DF2-5F60CF8BF486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5E0C0DBA-96AF-ED47-BA39-23901BC7528A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CE286298-1392-684D-BDC4-76B07D7D127A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97A719F7-AE02-0945-9936-BF18ECF6673C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CA7A934E-B4BA-4448-976C-D62E6EB95629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802E9B1E-C33B-534C-A9B7-06055C451F6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BEF2D13A-930F-9E4E-B0E4-081A61160633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26D41267-0FC4-164B-B40D-DFB399F0D63E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D925E47F-202D-944F-BC58-725B70DE9C8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504EAAA2-C77C-2046-B2CC-E832A1380F57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E5D66BB3-1875-E040-BFBE-48E2156918A5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B0393D6E-A00A-1245-9215-6115CAD8256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F569EBB7-D880-484F-9AC5-11C557845D60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A15DF79D-F5A0-4546-9009-1CC948E3143A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2236EE77-691D-5F4B-84F6-E08E48B53F2A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523F8B28-627F-444A-8AE2-BD7F38C05CA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C9FE0A6F-37AB-9147-A11C-AAF09DAEC3C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2942736D-ABAC-D441-B94B-C5C9C10F9256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517F7966-218B-C64E-81E6-4A44FECB4E7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EEAEB887-ED5B-2347-9727-9D78A79474C9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3E1B7224-23BC-6846-AE4A-4339CE44D56B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0CBD2DEB-BF66-724D-BCA1-BCC7E4DDBAA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D12E9F16-151D-8949-9DB1-E4AA2B235A8D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E144D161-A2C4-634C-ADC1-40F849D96F5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65" name="图片 64">
                <a:extLst>
                  <a:ext uri="{FF2B5EF4-FFF2-40B4-BE49-F238E27FC236}">
                    <a16:creationId xmlns:a16="http://schemas.microsoft.com/office/drawing/2014/main" id="{4D5C76B4-D6F4-ED46-A187-1C4AA2853D60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0976B2DB-BA39-4846-B291-42176350F8E0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67" name="图片 66">
                <a:extLst>
                  <a:ext uri="{FF2B5EF4-FFF2-40B4-BE49-F238E27FC236}">
                    <a16:creationId xmlns:a16="http://schemas.microsoft.com/office/drawing/2014/main" id="{6F40D61A-EB6D-9B4D-9453-2A45CB64F39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ACC05E10-4B2C-F249-95F1-A45A8322E7F1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60919149-25C2-BC43-AF12-E6D98FC591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F85327D6-DDBE-1140-BD3C-1D4358176493}"/>
              </a:ext>
            </a:extLst>
          </p:cNvPr>
          <p:cNvSpPr txBox="1"/>
          <p:nvPr/>
        </p:nvSpPr>
        <p:spPr>
          <a:xfrm>
            <a:off x="3499482" y="3498323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ASL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2684766" y="8967537"/>
            <a:ext cx="59442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1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BASL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29319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DCFC5782-C77F-304E-980F-E48537C8E767}"/>
              </a:ext>
            </a:extLst>
          </p:cNvPr>
          <p:cNvGrpSpPr/>
          <p:nvPr/>
        </p:nvGrpSpPr>
        <p:grpSpPr>
          <a:xfrm>
            <a:off x="721303" y="952559"/>
            <a:ext cx="2537784" cy="5190493"/>
            <a:chOff x="1851343" y="1128291"/>
            <a:chExt cx="2537784" cy="5190493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A7243543-59C2-C64C-9446-71870CA1B64F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A054DF07-0D68-9449-9C72-318B4E56F4BE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B5338C29-79E9-2D43-B6A5-854F0ED6B79F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5FD2BCA8-1CF1-144C-98B3-D5155AD1F42F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F121E217-58D7-764F-9B8E-0D97CA703D42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A328535F-5716-7946-9477-F9AFCB22D26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CFFEF11-C385-D445-8561-6B928C64BDAC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C1182F2D-6076-7C4F-BAED-76C86CA396DF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4011A63D-BF86-F147-9FA1-90FCD8030E9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CFE96CAB-C03A-144F-9657-3A33C10BCA42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66D8757-F185-824D-A7B9-9EB89D8DCAD1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5556FAF6-616C-B149-9A61-AA4ECCEA0FC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CA7DB9E4-50E3-0041-AC7E-D7FE54E5C6EF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562083C9-788C-6C41-8BA3-6148DDC88BDF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89785ACD-7DFE-5045-882D-7A871E33EE38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80F62A86-CD0C-104A-ADC1-46C1FF56602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C8F661C4-CC90-4947-B2C0-0594283DC62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8F60D27E-E8E7-2D4C-820C-416BCCDBFAD6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058944A9-EC20-AE48-B6A6-BCB2C0D4D04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F91120E8-1C72-B045-9448-B74EC3EDE427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994B3618-1ABA-B041-82C8-2E4620EE2A6F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E6BCAA00-81A7-054B-9EC7-345B630E642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35DE598-5EE3-9D48-9A6C-102FCD849C77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762E15DB-4DC1-A541-9D4E-2DE4B1FC7BFE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483AA1D9-53B7-4B48-8512-B5F468DE560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D7DC23CC-9455-654E-BF47-108FFCA58B49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6DB0D216-5E0A-1F40-8020-8D64412B46C9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EFD59B09-E7C6-2640-B678-4AC511E9F909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C91CDADB-CC0F-CE4C-B7B9-5BB4F0B521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pic>
        <p:nvPicPr>
          <p:cNvPr id="35" name="图片 34">
            <a:extLst>
              <a:ext uri="{FF2B5EF4-FFF2-40B4-BE49-F238E27FC236}">
                <a16:creationId xmlns:a16="http://schemas.microsoft.com/office/drawing/2014/main" id="{E055D443-1225-5645-994B-8D915900087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59087" y="68422"/>
            <a:ext cx="6385371" cy="7787843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CA4492BB-7BEB-7D43-9CF8-A3B28C74ECFE}"/>
              </a:ext>
            </a:extLst>
          </p:cNvPr>
          <p:cNvSpPr txBox="1"/>
          <p:nvPr/>
        </p:nvSpPr>
        <p:spPr>
          <a:xfrm>
            <a:off x="5780315" y="4912057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CRM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椭圆 36">
            <a:extLst>
              <a:ext uri="{FF2B5EF4-FFF2-40B4-BE49-F238E27FC236}">
                <a16:creationId xmlns:a16="http://schemas.microsoft.com/office/drawing/2014/main" id="{E0D58514-7DA9-754D-BBF2-FFDE645BC282}"/>
              </a:ext>
            </a:extLst>
          </p:cNvPr>
          <p:cNvSpPr/>
          <p:nvPr/>
        </p:nvSpPr>
        <p:spPr>
          <a:xfrm>
            <a:off x="5012886" y="6333902"/>
            <a:ext cx="1707109" cy="1275212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zh-CN" altLang="en-US"/>
          </a:p>
        </p:txBody>
      </p:sp>
      <p:sp>
        <p:nvSpPr>
          <p:cNvPr id="38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499242" y="8458044"/>
            <a:ext cx="62360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10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SCRM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4251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0D2FBCE8-51D2-B749-BF73-622A6F3E80EF}"/>
              </a:ext>
            </a:extLst>
          </p:cNvPr>
          <p:cNvGrpSpPr/>
          <p:nvPr/>
        </p:nvGrpSpPr>
        <p:grpSpPr>
          <a:xfrm>
            <a:off x="1000730" y="1393430"/>
            <a:ext cx="2537784" cy="5190493"/>
            <a:chOff x="1851343" y="1128291"/>
            <a:chExt cx="2537784" cy="5190493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D0DA70C-F80C-5E41-9597-88D1CCE5FC03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D3092D68-97D8-034F-BEBA-23713709C1EA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0B7E3EA-0143-8E40-9497-7B6167D2B1E5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AC96E9DA-2BA2-7744-AFD7-42B1DC9C94EF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052DC5E3-BF44-A44B-8692-415329C480FE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079D117C-980D-934A-9C46-E01F0595B87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DFFADA99-D715-A14E-B565-F90EEFABD220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121D6AF4-C81C-7E42-A7F8-3F30213D6392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1AC40295-AE61-CA46-8836-08A19C47720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5D43E19-C68A-0544-A8E9-F2E55A573084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0C01CD59-3B2C-094B-8A65-F8F7C5F614EF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F7E60254-383C-E04B-939C-D3B5DD9E310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AC6A58F4-6027-624A-AAD2-6CD5ED20DF1F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B88C0900-10CE-9344-A168-45C9BDD59B40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5E9B1D97-5193-1445-B7F4-AB57D94350E8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35B3C735-4ABA-4944-8352-4081BF7EA37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73C6B330-6580-F44C-8170-AA92134E5C1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EC5EC6FF-4309-6E4F-A29F-E12ECC626581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076D5676-CE0B-CF45-AA46-2EA0328BDB9E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ECDB68E2-4555-C14D-B90A-AC6656BFBF83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3A6649F-0845-5147-B6A8-2E3D296A29B4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F827D547-1EB9-574F-A884-E1F00B8FE90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7E4C4986-1BEF-9D4A-B328-2EEEBF819A88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23A7929E-0D13-454B-A7D6-EC3107CBD3D0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1A437D9B-AB3F-4B47-A13F-F4DF867632A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CB976C01-ECB4-874E-8DA2-9D3BB47F3F8F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76BCA5C2-DC52-5D4A-91D1-ED5F955B8A4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0C16021B-5439-D943-AF51-80BFE1F2561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DF040922-1217-944C-9D55-D89C9891E2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5B5B5B9C-3D2F-3C44-A439-8D041751C2D0}"/>
              </a:ext>
            </a:extLst>
          </p:cNvPr>
          <p:cNvGrpSpPr/>
          <p:nvPr/>
        </p:nvGrpSpPr>
        <p:grpSpPr>
          <a:xfrm>
            <a:off x="3326827" y="241452"/>
            <a:ext cx="8132567" cy="7422482"/>
            <a:chOff x="1098550" y="133350"/>
            <a:chExt cx="10604500" cy="9334500"/>
          </a:xfrm>
        </p:grpSpPr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5DE45E32-2DCA-BD4A-B899-7D11719D6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098550" y="133350"/>
              <a:ext cx="10604500" cy="9334500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9BE3F2FD-1229-054B-BD8C-F6DE22C825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454024" y="4358775"/>
              <a:ext cx="2578100" cy="368300"/>
            </a:xfrm>
            <a:prstGeom prst="rect">
              <a:avLst/>
            </a:prstGeom>
          </p:spPr>
        </p:pic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0AD28C2E-6907-B84D-B30D-99E67D60D48F}"/>
              </a:ext>
            </a:extLst>
          </p:cNvPr>
          <p:cNvSpPr txBox="1"/>
          <p:nvPr/>
        </p:nvSpPr>
        <p:spPr>
          <a:xfrm>
            <a:off x="5900132" y="3987916"/>
            <a:ext cx="13821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OLAR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椭圆 37">
            <a:extLst>
              <a:ext uri="{FF2B5EF4-FFF2-40B4-BE49-F238E27FC236}">
                <a16:creationId xmlns:a16="http://schemas.microsoft.com/office/drawing/2014/main" id="{6D6D95AC-46AA-C84D-A1FA-BF701E425B2A}"/>
              </a:ext>
            </a:extLst>
          </p:cNvPr>
          <p:cNvSpPr/>
          <p:nvPr/>
        </p:nvSpPr>
        <p:spPr>
          <a:xfrm>
            <a:off x="9229452" y="241452"/>
            <a:ext cx="1278127" cy="1484875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/>
          </a:p>
        </p:txBody>
      </p:sp>
      <p:sp>
        <p:nvSpPr>
          <p:cNvPr id="3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179441" y="8856289"/>
            <a:ext cx="62007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2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POLAR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02503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91863449-7123-A443-B310-9AA0040C488F}"/>
              </a:ext>
            </a:extLst>
          </p:cNvPr>
          <p:cNvGrpSpPr/>
          <p:nvPr/>
        </p:nvGrpSpPr>
        <p:grpSpPr>
          <a:xfrm>
            <a:off x="1039592" y="1335929"/>
            <a:ext cx="2537784" cy="5190493"/>
            <a:chOff x="1851343" y="1128291"/>
            <a:chExt cx="2537784" cy="5190493"/>
          </a:xfrm>
        </p:grpSpPr>
        <p:sp>
          <p:nvSpPr>
            <p:cNvPr id="5" name="文本框 7">
              <a:extLst>
                <a:ext uri="{FF2B5EF4-FFF2-40B4-BE49-F238E27FC236}">
                  <a16:creationId xmlns:a16="http://schemas.microsoft.com/office/drawing/2014/main" id="{B8D7E51E-AF6C-EF48-B4C7-5E4AA5CD5124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B2E3CF8D-B74F-114C-B043-2FC8218DD2DF}"/>
                </a:ext>
              </a:extLst>
            </p:cNvPr>
            <p:cNvGrpSpPr/>
            <p:nvPr/>
          </p:nvGrpSpPr>
          <p:grpSpPr>
            <a:xfrm>
              <a:off x="1851343" y="1128291"/>
              <a:ext cx="2278097" cy="5190493"/>
              <a:chOff x="1851343" y="1128291"/>
              <a:chExt cx="2278097" cy="5190493"/>
            </a:xfrm>
          </p:grpSpPr>
          <p:sp>
            <p:nvSpPr>
              <p:cNvPr id="7" name="文本框 9">
                <a:extLst>
                  <a:ext uri="{FF2B5EF4-FFF2-40B4-BE49-F238E27FC236}">
                    <a16:creationId xmlns:a16="http://schemas.microsoft.com/office/drawing/2014/main" id="{123BFC61-E1EF-6248-B0B6-4A6656D3FC50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310FBB17-1F2B-BE4C-A5E8-5D98FB5D47B6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11">
                <a:extLst>
                  <a:ext uri="{FF2B5EF4-FFF2-40B4-BE49-F238E27FC236}">
                    <a16:creationId xmlns:a16="http://schemas.microsoft.com/office/drawing/2014/main" id="{1D57F230-E82C-4A47-990C-877A725D8B1C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CD492D95-3B60-2A48-B309-269FABBC80A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3">
                <a:extLst>
                  <a:ext uri="{FF2B5EF4-FFF2-40B4-BE49-F238E27FC236}">
                    <a16:creationId xmlns:a16="http://schemas.microsoft.com/office/drawing/2014/main" id="{A2024341-9482-0040-8265-BD925184B428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4">
                <a:extLst>
                  <a:ext uri="{FF2B5EF4-FFF2-40B4-BE49-F238E27FC236}">
                    <a16:creationId xmlns:a16="http://schemas.microsoft.com/office/drawing/2014/main" id="{9FC91652-1179-B746-AF64-CBA13BA67C7A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AE253044-8520-EB40-AC99-60FA9160B5E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6">
                <a:extLst>
                  <a:ext uri="{FF2B5EF4-FFF2-40B4-BE49-F238E27FC236}">
                    <a16:creationId xmlns:a16="http://schemas.microsoft.com/office/drawing/2014/main" id="{FEB9EF61-7220-6846-BD7D-F4AA6422649F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896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7">
                <a:extLst>
                  <a:ext uri="{FF2B5EF4-FFF2-40B4-BE49-F238E27FC236}">
                    <a16:creationId xmlns:a16="http://schemas.microsoft.com/office/drawing/2014/main" id="{ED13BD4D-E726-474E-BA62-9210A29AC6F8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7059AF7C-C80A-D547-A77E-BB4DD159939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9">
                <a:extLst>
                  <a:ext uri="{FF2B5EF4-FFF2-40B4-BE49-F238E27FC236}">
                    <a16:creationId xmlns:a16="http://schemas.microsoft.com/office/drawing/2014/main" id="{D6747F60-9FDC-DF46-95E5-0B0F219BE932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20">
                <a:extLst>
                  <a:ext uri="{FF2B5EF4-FFF2-40B4-BE49-F238E27FC236}">
                    <a16:creationId xmlns:a16="http://schemas.microsoft.com/office/drawing/2014/main" id="{359548CE-1073-1B4B-B27E-141214874FEA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21">
                <a:extLst>
                  <a:ext uri="{FF2B5EF4-FFF2-40B4-BE49-F238E27FC236}">
                    <a16:creationId xmlns:a16="http://schemas.microsoft.com/office/drawing/2014/main" id="{FEB041AE-F3A8-1A4A-B086-1FA6C9328F50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0E557C48-4617-8046-A2CB-A37D08346B9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B1C73401-39FA-8F42-A7E4-EC288F3BC5F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24DD7D67-624B-AA45-92A9-12BE597A4B54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164745C7-060E-8E46-B08E-0C27EAFFE87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6">
                <a:extLst>
                  <a:ext uri="{FF2B5EF4-FFF2-40B4-BE49-F238E27FC236}">
                    <a16:creationId xmlns:a16="http://schemas.microsoft.com/office/drawing/2014/main" id="{AF0A51B8-C332-0045-97DF-496186BC163B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7">
                <a:extLst>
                  <a:ext uri="{FF2B5EF4-FFF2-40B4-BE49-F238E27FC236}">
                    <a16:creationId xmlns:a16="http://schemas.microsoft.com/office/drawing/2014/main" id="{3D197F4D-AFC5-C749-BB30-B17FF20FDD52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5652259A-7C06-8A46-940D-6197646F690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9">
                <a:extLst>
                  <a:ext uri="{FF2B5EF4-FFF2-40B4-BE49-F238E27FC236}">
                    <a16:creationId xmlns:a16="http://schemas.microsoft.com/office/drawing/2014/main" id="{F41FB24C-A1C2-0C49-B6EB-497B837EA2F6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EAB7DAC7-E81D-A44B-9760-97924DF8F36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0027F4CC-F188-BF44-8E3F-E6A0C65771C3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0B564FE5-23B1-2148-8A3C-E9952625433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231895B0-200C-814E-AA1F-03BCF4626C0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099BFBED-611D-414C-B072-660C3AC0CDB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511CDF3A-D198-AB4A-A3A4-091283C264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7C2ECE01-9A47-7E45-8970-81C8D74194CC}"/>
              </a:ext>
            </a:extLst>
          </p:cNvPr>
          <p:cNvGrpSpPr/>
          <p:nvPr/>
        </p:nvGrpSpPr>
        <p:grpSpPr>
          <a:xfrm>
            <a:off x="3577376" y="369394"/>
            <a:ext cx="6160490" cy="6705174"/>
            <a:chOff x="3865826" y="465647"/>
            <a:chExt cx="5614737" cy="6187818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AF31946D-BA75-BC49-A61D-BFEEF88E2388}"/>
                </a:ext>
              </a:extLst>
            </p:cNvPr>
            <p:cNvGrpSpPr/>
            <p:nvPr/>
          </p:nvGrpSpPr>
          <p:grpSpPr>
            <a:xfrm>
              <a:off x="3865826" y="465647"/>
              <a:ext cx="5614737" cy="6187818"/>
              <a:chOff x="2216150" y="0"/>
              <a:chExt cx="8369300" cy="9601200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14415269-A140-DB43-BCD5-F803A57FCF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2216150" y="0"/>
                <a:ext cx="8369300" cy="9601200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49366B77-4484-A040-8528-750656C184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577376" y="5883513"/>
                <a:ext cx="2616200" cy="317500"/>
              </a:xfrm>
              <a:prstGeom prst="rect">
                <a:avLst/>
              </a:prstGeom>
            </p:spPr>
          </p:pic>
        </p:grp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7F6B98E5-AC5F-BF4B-8EB3-6C9C60C36705}"/>
                </a:ext>
              </a:extLst>
            </p:cNvPr>
            <p:cNvSpPr txBox="1"/>
            <p:nvPr/>
          </p:nvSpPr>
          <p:spPr>
            <a:xfrm>
              <a:off x="6606860" y="4199462"/>
              <a:ext cx="853513" cy="426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EPFs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椭圆 36">
            <a:extLst>
              <a:ext uri="{FF2B5EF4-FFF2-40B4-BE49-F238E27FC236}">
                <a16:creationId xmlns:a16="http://schemas.microsoft.com/office/drawing/2014/main" id="{0BBC63D6-E336-A045-AD0B-FCD6EAC7AA5C}"/>
              </a:ext>
            </a:extLst>
          </p:cNvPr>
          <p:cNvSpPr/>
          <p:nvPr/>
        </p:nvSpPr>
        <p:spPr>
          <a:xfrm rot="2627537">
            <a:off x="5167766" y="1694392"/>
            <a:ext cx="883229" cy="759366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/>
          </a:p>
        </p:txBody>
      </p:sp>
      <p:sp>
        <p:nvSpPr>
          <p:cNvPr id="3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218303" y="8641950"/>
            <a:ext cx="57551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3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EPF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1024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>
            <a:extLst>
              <a:ext uri="{FF2B5EF4-FFF2-40B4-BE49-F238E27FC236}">
                <a16:creationId xmlns:a16="http://schemas.microsoft.com/office/drawing/2014/main" id="{D68A5922-7759-544D-A534-A5BABD368316}"/>
              </a:ext>
            </a:extLst>
          </p:cNvPr>
          <p:cNvGrpSpPr/>
          <p:nvPr/>
        </p:nvGrpSpPr>
        <p:grpSpPr>
          <a:xfrm>
            <a:off x="3109208" y="501415"/>
            <a:ext cx="7535448" cy="6858000"/>
            <a:chOff x="2633076" y="1371600"/>
            <a:chExt cx="7535448" cy="6858000"/>
          </a:xfrm>
        </p:grpSpPr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046A083B-954B-214D-BD9D-3A50FF50725F}"/>
                </a:ext>
              </a:extLst>
            </p:cNvPr>
            <p:cNvGrpSpPr/>
            <p:nvPr/>
          </p:nvGrpSpPr>
          <p:grpSpPr>
            <a:xfrm>
              <a:off x="2633076" y="1371600"/>
              <a:ext cx="7535448" cy="6858000"/>
              <a:chOff x="2633076" y="1371600"/>
              <a:chExt cx="7535448" cy="6858000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636AF476-657E-5D4F-80DC-29D877115F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633076" y="1371600"/>
                <a:ext cx="7535448" cy="6858000"/>
              </a:xfrm>
              <a:prstGeom prst="rect">
                <a:avLst/>
              </a:prstGeom>
            </p:spPr>
          </p:pic>
          <p:sp>
            <p:nvSpPr>
              <p:cNvPr id="36" name="椭圆 35">
                <a:extLst>
                  <a:ext uri="{FF2B5EF4-FFF2-40B4-BE49-F238E27FC236}">
                    <a16:creationId xmlns:a16="http://schemas.microsoft.com/office/drawing/2014/main" id="{FFC98CB0-705C-0848-A512-0FBC8D018C3D}"/>
                  </a:ext>
                </a:extLst>
              </p:cNvPr>
              <p:cNvSpPr/>
              <p:nvPr/>
            </p:nvSpPr>
            <p:spPr>
              <a:xfrm rot="2627537">
                <a:off x="3598145" y="1890996"/>
                <a:ext cx="1136303" cy="119884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kumimoji="1" lang="zh-CN" altLang="en-US"/>
              </a:p>
            </p:txBody>
          </p:sp>
        </p:grp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135FB36B-75EB-AD4D-8F1D-EF21A160D2BA}"/>
                </a:ext>
              </a:extLst>
            </p:cNvPr>
            <p:cNvSpPr txBox="1"/>
            <p:nvPr/>
          </p:nvSpPr>
          <p:spPr>
            <a:xfrm>
              <a:off x="6751880" y="4140528"/>
              <a:ext cx="12795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EPFL9s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7A79E07E-96B7-AC45-8DC0-2F128363B4FC}"/>
              </a:ext>
            </a:extLst>
          </p:cNvPr>
          <p:cNvGrpSpPr/>
          <p:nvPr/>
        </p:nvGrpSpPr>
        <p:grpSpPr>
          <a:xfrm>
            <a:off x="1039592" y="1335929"/>
            <a:ext cx="2537784" cy="5190493"/>
            <a:chOff x="1851343" y="1128291"/>
            <a:chExt cx="2537784" cy="5190493"/>
          </a:xfrm>
        </p:grpSpPr>
        <p:sp>
          <p:nvSpPr>
            <p:cNvPr id="7" name="文本框 7">
              <a:extLst>
                <a:ext uri="{FF2B5EF4-FFF2-40B4-BE49-F238E27FC236}">
                  <a16:creationId xmlns:a16="http://schemas.microsoft.com/office/drawing/2014/main" id="{889FC0F6-EB0A-B545-B404-3D63F064C9F1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A9319A8D-E0B8-EC42-9C67-C5DDC1AF0A33}"/>
                </a:ext>
              </a:extLst>
            </p:cNvPr>
            <p:cNvGrpSpPr/>
            <p:nvPr/>
          </p:nvGrpSpPr>
          <p:grpSpPr>
            <a:xfrm>
              <a:off x="1851343" y="1128291"/>
              <a:ext cx="2278097" cy="5190493"/>
              <a:chOff x="1851343" y="1128291"/>
              <a:chExt cx="2278097" cy="5190493"/>
            </a:xfrm>
          </p:grpSpPr>
          <p:sp>
            <p:nvSpPr>
              <p:cNvPr id="9" name="文本框 9">
                <a:extLst>
                  <a:ext uri="{FF2B5EF4-FFF2-40B4-BE49-F238E27FC236}">
                    <a16:creationId xmlns:a16="http://schemas.microsoft.com/office/drawing/2014/main" id="{71B8D8B4-7E36-1A4B-89E0-27A7A9F45B2B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635D2838-5B6C-1A42-920C-8F106842A3F6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1">
                <a:extLst>
                  <a:ext uri="{FF2B5EF4-FFF2-40B4-BE49-F238E27FC236}">
                    <a16:creationId xmlns:a16="http://schemas.microsoft.com/office/drawing/2014/main" id="{E54D8525-D357-C145-B992-6453502FC587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4F32B6F5-6808-0549-B05B-90AAD217280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3" name="文本框 13">
                <a:extLst>
                  <a:ext uri="{FF2B5EF4-FFF2-40B4-BE49-F238E27FC236}">
                    <a16:creationId xmlns:a16="http://schemas.microsoft.com/office/drawing/2014/main" id="{66910747-0C11-F146-B0ED-1E732D78458A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4">
                <a:extLst>
                  <a:ext uri="{FF2B5EF4-FFF2-40B4-BE49-F238E27FC236}">
                    <a16:creationId xmlns:a16="http://schemas.microsoft.com/office/drawing/2014/main" id="{B58DD3C2-500A-4640-A2B9-CD8CA78085A2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56CFBB55-9934-9E4E-B05D-1F75FF3152A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6" name="文本框 16">
                <a:extLst>
                  <a:ext uri="{FF2B5EF4-FFF2-40B4-BE49-F238E27FC236}">
                    <a16:creationId xmlns:a16="http://schemas.microsoft.com/office/drawing/2014/main" id="{C083FC57-E856-E041-BAF0-3CAFBC5DF4E5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896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7">
                <a:extLst>
                  <a:ext uri="{FF2B5EF4-FFF2-40B4-BE49-F238E27FC236}">
                    <a16:creationId xmlns:a16="http://schemas.microsoft.com/office/drawing/2014/main" id="{96DE324D-69E6-E547-BDF6-FE65BA3BA311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5F82FD33-2959-4D46-907E-CC841BC3CE3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9" name="文本框 19">
                <a:extLst>
                  <a:ext uri="{FF2B5EF4-FFF2-40B4-BE49-F238E27FC236}">
                    <a16:creationId xmlns:a16="http://schemas.microsoft.com/office/drawing/2014/main" id="{0C6CB4A0-CAF2-274F-9CB2-BF0F408AF29E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20">
                <a:extLst>
                  <a:ext uri="{FF2B5EF4-FFF2-40B4-BE49-F238E27FC236}">
                    <a16:creationId xmlns:a16="http://schemas.microsoft.com/office/drawing/2014/main" id="{1B27A928-A57E-AA4A-AC79-CBF5E6D11596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1">
                <a:extLst>
                  <a:ext uri="{FF2B5EF4-FFF2-40B4-BE49-F238E27FC236}">
                    <a16:creationId xmlns:a16="http://schemas.microsoft.com/office/drawing/2014/main" id="{6CC67B24-AFDB-7F48-BE34-C01C65ACB8C9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5BAA2274-0543-ED49-AD20-1149701D93B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4B5FF10D-9EBE-1441-B002-AD07DA95236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496349BD-68B0-024A-BFD3-25068BF4AEDE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81BAB65A-01AF-884E-B86B-71D71F0CBD0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6" name="文本框 26">
                <a:extLst>
                  <a:ext uri="{FF2B5EF4-FFF2-40B4-BE49-F238E27FC236}">
                    <a16:creationId xmlns:a16="http://schemas.microsoft.com/office/drawing/2014/main" id="{EFE614BB-C6B5-C44E-8BF8-B6CF38933182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7">
                <a:extLst>
                  <a:ext uri="{FF2B5EF4-FFF2-40B4-BE49-F238E27FC236}">
                    <a16:creationId xmlns:a16="http://schemas.microsoft.com/office/drawing/2014/main" id="{42405186-AE02-7F4A-82BD-864806DFDCAA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9812C4F8-DD99-6544-A38C-A546F43788F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9" name="文本框 29">
                <a:extLst>
                  <a:ext uri="{FF2B5EF4-FFF2-40B4-BE49-F238E27FC236}">
                    <a16:creationId xmlns:a16="http://schemas.microsoft.com/office/drawing/2014/main" id="{587449A3-34A1-1445-B17E-01678B633552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9829C990-8849-B743-851C-2A6D67593AC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9E3DD844-4142-D148-933B-EBB89F120BE1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75D2690D-07A5-CD44-B4F7-15144DF38C7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12549D0A-70A7-9345-8A68-5628DA8B49E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9FEBA240-E0C2-FE4C-97DF-3EC770B4BB3E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262A85F9-E3F8-9841-B2C2-962F4218D6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pic>
        <p:nvPicPr>
          <p:cNvPr id="38" name="图片 37">
            <a:extLst>
              <a:ext uri="{FF2B5EF4-FFF2-40B4-BE49-F238E27FC236}">
                <a16:creationId xmlns:a16="http://schemas.microsoft.com/office/drawing/2014/main" id="{019191CE-3E88-5842-A8C7-FA50B8C0D09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440951" y="3359031"/>
            <a:ext cx="1727200" cy="330200"/>
          </a:xfrm>
          <a:prstGeom prst="rect">
            <a:avLst/>
          </a:prstGeom>
        </p:spPr>
      </p:pic>
      <p:sp>
        <p:nvSpPr>
          <p:cNvPr id="3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077239" y="8711453"/>
            <a:ext cx="6098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4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EPFL9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2523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88EA9591-2F9D-3544-9559-EA54828F62EF}"/>
              </a:ext>
            </a:extLst>
          </p:cNvPr>
          <p:cNvGrpSpPr/>
          <p:nvPr/>
        </p:nvGrpSpPr>
        <p:grpSpPr>
          <a:xfrm>
            <a:off x="1000730" y="1393430"/>
            <a:ext cx="2537784" cy="5190493"/>
            <a:chOff x="1851343" y="1128291"/>
            <a:chExt cx="2537784" cy="5190493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9ADF1F9-8278-774F-B08F-781415C5FAAD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B583199-B688-AB46-9376-3F489BBC6184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10B9102-C624-7147-A397-526C20BFCA43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7DBFBF49-ADDE-D14A-80ED-73878FE6B08F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B8FE7074-F069-3541-B2B7-CA09AA5CF8F8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2F52EAAC-6102-4545-A9EC-92537CC17D3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39C2DDE5-9A29-B64C-9EED-0FF67528B001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DD24533D-D7F4-1D4C-A4C7-5FF4354C4FFD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A1233652-AA3D-BE41-96F8-811A56CCF1D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75BE63D-5EE8-1247-8433-FE0067B5AA4F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08484C90-A9CE-9241-A951-54351142CB63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6402F3C2-50E7-9943-BF41-56631BF1A4F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49C51808-0869-9549-AAAC-101AC62D36C4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E75F520-B319-8543-91DC-FEFE2EF6FAAA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C5BC9D17-CCAA-D342-A85F-D5B9EF2A2C1F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A5842DAB-5FB7-CA43-9159-DCC8248D69A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E8962A9D-041B-674F-BFAB-B0EA1DC3564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43467541-BD1B-8B42-9D91-21177A13894F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5B624AAB-6DEA-DF42-A199-9F714C84AE0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6AA3EB02-6DF9-354E-AB67-4C2708296128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8A53A1A-2628-854C-A524-9FC5A4CC4453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0DD2D5C8-9E39-834A-807E-E11001DD022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12F55646-B75E-894F-B335-4BAEB70749A6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7EC68A84-C4B9-C545-BB31-BAE54263B44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2F4D33A6-64F4-5145-953D-A72B82A75547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50AB5FC4-CEAD-3141-9728-862B69FE7148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A7336BD9-4727-AD4A-987B-E7D9C427F5A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7FD704E1-347D-A04F-8416-CA84869016D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E47C9F97-CB2A-6C40-A6B7-883AE63381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pic>
        <p:nvPicPr>
          <p:cNvPr id="35" name="图片 34">
            <a:extLst>
              <a:ext uri="{FF2B5EF4-FFF2-40B4-BE49-F238E27FC236}">
                <a16:creationId xmlns:a16="http://schemas.microsoft.com/office/drawing/2014/main" id="{7FA51090-C3FA-F248-96CD-BB0C55C7D34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90013" y="501132"/>
            <a:ext cx="8932784" cy="6319921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2062AF62-A71F-624A-A93F-4879450817CD}"/>
              </a:ext>
            </a:extLst>
          </p:cNvPr>
          <p:cNvSpPr txBox="1"/>
          <p:nvPr/>
        </p:nvSpPr>
        <p:spPr>
          <a:xfrm>
            <a:off x="8004005" y="3298080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EPFL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椭圆 36">
            <a:extLst>
              <a:ext uri="{FF2B5EF4-FFF2-40B4-BE49-F238E27FC236}">
                <a16:creationId xmlns:a16="http://schemas.microsoft.com/office/drawing/2014/main" id="{EB002E53-D74E-2747-A7B9-B4AAD7EA7FD9}"/>
              </a:ext>
            </a:extLst>
          </p:cNvPr>
          <p:cNvSpPr/>
          <p:nvPr/>
        </p:nvSpPr>
        <p:spPr>
          <a:xfrm rot="18862092">
            <a:off x="10183090" y="4456651"/>
            <a:ext cx="670852" cy="1159062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/>
          </a:p>
        </p:txBody>
      </p:sp>
      <p:sp>
        <p:nvSpPr>
          <p:cNvPr id="38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2781896" y="8500084"/>
            <a:ext cx="59266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5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EPFL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6998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1FF3EF9A-1ED0-A943-BA0B-4C2D5F0F5B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4368" y="442498"/>
            <a:ext cx="8548983" cy="7647509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FB0AECBC-C8C2-7349-A391-1BDA1867A465}"/>
              </a:ext>
            </a:extLst>
          </p:cNvPr>
          <p:cNvGrpSpPr/>
          <p:nvPr/>
        </p:nvGrpSpPr>
        <p:grpSpPr>
          <a:xfrm>
            <a:off x="1039592" y="1335929"/>
            <a:ext cx="2537784" cy="5190493"/>
            <a:chOff x="1851343" y="1128291"/>
            <a:chExt cx="2537784" cy="5190493"/>
          </a:xfrm>
        </p:grpSpPr>
        <p:sp>
          <p:nvSpPr>
            <p:cNvPr id="5" name="文本框 7">
              <a:extLst>
                <a:ext uri="{FF2B5EF4-FFF2-40B4-BE49-F238E27FC236}">
                  <a16:creationId xmlns:a16="http://schemas.microsoft.com/office/drawing/2014/main" id="{92413573-A1A4-8843-9C1A-E7DC66442195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4A2D777-DE8E-9F4A-8293-802F36FBF249}"/>
                </a:ext>
              </a:extLst>
            </p:cNvPr>
            <p:cNvGrpSpPr/>
            <p:nvPr/>
          </p:nvGrpSpPr>
          <p:grpSpPr>
            <a:xfrm>
              <a:off x="1851343" y="1128291"/>
              <a:ext cx="2278097" cy="5190493"/>
              <a:chOff x="1851343" y="1128291"/>
              <a:chExt cx="2278097" cy="5190493"/>
            </a:xfrm>
          </p:grpSpPr>
          <p:sp>
            <p:nvSpPr>
              <p:cNvPr id="7" name="文本框 9">
                <a:extLst>
                  <a:ext uri="{FF2B5EF4-FFF2-40B4-BE49-F238E27FC236}">
                    <a16:creationId xmlns:a16="http://schemas.microsoft.com/office/drawing/2014/main" id="{29327AC2-01F1-314E-B1C8-B4C5D10E2BB5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46A0B0E4-0B64-D249-BD16-D47847D10E90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11">
                <a:extLst>
                  <a:ext uri="{FF2B5EF4-FFF2-40B4-BE49-F238E27FC236}">
                    <a16:creationId xmlns:a16="http://schemas.microsoft.com/office/drawing/2014/main" id="{8DC2BF89-22A5-0C4C-9157-ED9143C0A3AD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6FCB83C2-9970-0547-A9A5-BFF0F597F3C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3">
                <a:extLst>
                  <a:ext uri="{FF2B5EF4-FFF2-40B4-BE49-F238E27FC236}">
                    <a16:creationId xmlns:a16="http://schemas.microsoft.com/office/drawing/2014/main" id="{38E17B7F-B81C-2446-A70C-616C285A2264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4">
                <a:extLst>
                  <a:ext uri="{FF2B5EF4-FFF2-40B4-BE49-F238E27FC236}">
                    <a16:creationId xmlns:a16="http://schemas.microsoft.com/office/drawing/2014/main" id="{90A25D06-1753-7A40-8981-A833A975FAF7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954F1881-272F-3242-8E0A-7A24BE84BBD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6">
                <a:extLst>
                  <a:ext uri="{FF2B5EF4-FFF2-40B4-BE49-F238E27FC236}">
                    <a16:creationId xmlns:a16="http://schemas.microsoft.com/office/drawing/2014/main" id="{02D250F2-BF8C-E445-B7D2-68AA12E4477F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896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7">
                <a:extLst>
                  <a:ext uri="{FF2B5EF4-FFF2-40B4-BE49-F238E27FC236}">
                    <a16:creationId xmlns:a16="http://schemas.microsoft.com/office/drawing/2014/main" id="{62962140-ED8F-8B4C-B90C-FD238583B44B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A51831A4-E389-FC4C-AED9-1EACF17846C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9">
                <a:extLst>
                  <a:ext uri="{FF2B5EF4-FFF2-40B4-BE49-F238E27FC236}">
                    <a16:creationId xmlns:a16="http://schemas.microsoft.com/office/drawing/2014/main" id="{93790996-73DC-624C-A3A5-8B3083F297D9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20">
                <a:extLst>
                  <a:ext uri="{FF2B5EF4-FFF2-40B4-BE49-F238E27FC236}">
                    <a16:creationId xmlns:a16="http://schemas.microsoft.com/office/drawing/2014/main" id="{3F0CC7F6-9414-C547-A582-DCB08690AB1B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21">
                <a:extLst>
                  <a:ext uri="{FF2B5EF4-FFF2-40B4-BE49-F238E27FC236}">
                    <a16:creationId xmlns:a16="http://schemas.microsoft.com/office/drawing/2014/main" id="{AEF487A7-6FEA-C848-8BD4-D88E34356D13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91B36A8C-F7A7-0D4C-A481-4E2D216E7FD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08EAAFEA-D4CA-534C-9095-254A1EAA32A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134B508B-1520-4D48-A1F4-BBE1570EB7D1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1028BB2F-F64F-9547-ADDC-574498C1DD3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6">
                <a:extLst>
                  <a:ext uri="{FF2B5EF4-FFF2-40B4-BE49-F238E27FC236}">
                    <a16:creationId xmlns:a16="http://schemas.microsoft.com/office/drawing/2014/main" id="{3047B4FC-C0EA-D64F-8045-07897C43AE80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7">
                <a:extLst>
                  <a:ext uri="{FF2B5EF4-FFF2-40B4-BE49-F238E27FC236}">
                    <a16:creationId xmlns:a16="http://schemas.microsoft.com/office/drawing/2014/main" id="{4D57D05F-852E-3D40-AA1A-0EF4CDF3E4F3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E18126FD-0723-C541-B88A-7465E8DCB0B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9">
                <a:extLst>
                  <a:ext uri="{FF2B5EF4-FFF2-40B4-BE49-F238E27FC236}">
                    <a16:creationId xmlns:a16="http://schemas.microsoft.com/office/drawing/2014/main" id="{3BEFB715-9E1C-D046-ACEC-6F67BC962738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B28C036F-BADE-C948-8600-88E0D680E4E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BF829505-8A31-6D41-93FF-1EFEAB89E95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83C59834-FAAF-9D44-A463-BD9751BEF988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009D3F10-5767-D041-98AB-20ADA0D2ADCA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5CE120CB-72AC-B24B-A86E-BF9BCE4D7953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BB17A9A1-6C48-4941-935B-FB4C95FFF8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7655A931-31CC-BB44-8293-A35D7CE33A4D}"/>
              </a:ext>
            </a:extLst>
          </p:cNvPr>
          <p:cNvSpPr txBox="1"/>
          <p:nvPr/>
        </p:nvSpPr>
        <p:spPr>
          <a:xfrm>
            <a:off x="5277850" y="3004031"/>
            <a:ext cx="9893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CR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椭圆 36">
            <a:extLst>
              <a:ext uri="{FF2B5EF4-FFF2-40B4-BE49-F238E27FC236}">
                <a16:creationId xmlns:a16="http://schemas.microsoft.com/office/drawing/2014/main" id="{E0D58514-7DA9-754D-BBF2-FFDE645BC282}"/>
              </a:ext>
            </a:extLst>
          </p:cNvPr>
          <p:cNvSpPr/>
          <p:nvPr/>
        </p:nvSpPr>
        <p:spPr>
          <a:xfrm rot="2627537">
            <a:off x="9659915" y="3149531"/>
            <a:ext cx="767428" cy="518645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/>
          </a:p>
        </p:txBody>
      </p:sp>
      <p:sp>
        <p:nvSpPr>
          <p:cNvPr id="38" name="椭圆 37">
            <a:extLst>
              <a:ext uri="{FF2B5EF4-FFF2-40B4-BE49-F238E27FC236}">
                <a16:creationId xmlns:a16="http://schemas.microsoft.com/office/drawing/2014/main" id="{0BBC63D6-E336-A045-AD0B-FCD6EAC7AA5C}"/>
              </a:ext>
            </a:extLst>
          </p:cNvPr>
          <p:cNvSpPr/>
          <p:nvPr/>
        </p:nvSpPr>
        <p:spPr>
          <a:xfrm rot="2627537">
            <a:off x="7977151" y="4983597"/>
            <a:ext cx="883229" cy="517906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zh-CN" altLang="en-US"/>
          </a:p>
        </p:txBody>
      </p:sp>
      <p:sp>
        <p:nvSpPr>
          <p:cNvPr id="3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317689" y="8371587"/>
            <a:ext cx="58080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6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SCR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7947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599680B-31DB-194A-8A4D-BBE4E4DD60DC}"/>
              </a:ext>
            </a:extLst>
          </p:cNvPr>
          <p:cNvGrpSpPr/>
          <p:nvPr/>
        </p:nvGrpSpPr>
        <p:grpSpPr>
          <a:xfrm>
            <a:off x="1000730" y="1393430"/>
            <a:ext cx="2537784" cy="5190493"/>
            <a:chOff x="1851343" y="1128291"/>
            <a:chExt cx="2537784" cy="5190493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0CF147E-61A2-894F-8AC6-731F59CA628E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16C93575-C998-6E4F-A6DC-C6CA9CAF49CA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35E70D1C-34A5-3243-8F2C-65B9A8BD2AAA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ACC1BE02-8F51-3D4D-B8A5-EEA6D3B2DF39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D6047CD-4257-0F40-9C1D-2B1D9774FBA6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6CF46922-1A04-8B46-8795-6BDF1E8AA97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D3823AD-44E6-A04D-915C-B833AFB46CBE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2940781C-4CEA-0249-8093-9F68BC9BD0AB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8210B5E5-4321-0045-B55F-B7D3D53CC97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51C0C0C5-6DAB-EB4E-A427-0165C4663BBE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B1A8F363-E48E-A54A-80B8-8E674BBAC378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48389723-2E95-EB47-B34C-3970011F417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6DA3EB1C-9CAE-D444-92BF-0C0B3B9FF0EE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3B037023-54EC-5049-A2CC-3DD6FC8821BF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435F5680-4D08-194C-8E41-7260243A7A6D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953FD7BE-F7D1-814E-81A3-F953721A157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DACD2A32-EF37-FC47-92CD-59DDE95FE64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69DB023B-1012-7641-BB7B-35EAFB1DDA2F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C91959AF-9D54-E94E-A4BA-D107C412B38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1BA07693-A1A2-B744-BA3D-97970683B706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1876E384-1A0B-ED4B-9641-7C03435108DD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2E1FDA03-7469-2A45-B687-2CDA536D0D2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D2A25A2E-D0BC-8843-923E-8908FE64E331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5B29D83C-517B-1E41-A42A-4CDC6C05379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6D973612-8A4B-5D42-B4B9-05DCA86F3368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568FCDAA-9410-5348-9CAA-8736D509E9C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9D3EA218-337D-5549-8C29-EB356B752F6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1D14D251-FF84-B140-BD64-6D1552397E4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5C859FDC-3E2A-5E4F-88F3-454CC31F4D0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18CA05FD-FDC2-4441-B0CB-6D3AEC5A460E}"/>
              </a:ext>
            </a:extLst>
          </p:cNvPr>
          <p:cNvSpPr txBox="1"/>
          <p:nvPr/>
        </p:nvSpPr>
        <p:spPr>
          <a:xfrm>
            <a:off x="6577261" y="3880376"/>
            <a:ext cx="9893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Rs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4F63DC09-B786-0F4F-9837-00E09BAE9E71}"/>
              </a:ext>
            </a:extLst>
          </p:cNvPr>
          <p:cNvGrpSpPr/>
          <p:nvPr/>
        </p:nvGrpSpPr>
        <p:grpSpPr>
          <a:xfrm>
            <a:off x="3373956" y="338271"/>
            <a:ext cx="6223247" cy="8356049"/>
            <a:chOff x="3826964" y="737802"/>
            <a:chExt cx="6223247" cy="8356049"/>
          </a:xfrm>
        </p:grpSpPr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4D13D6A4-82A4-754D-9EAF-B41997F5B25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826964" y="737802"/>
              <a:ext cx="6223247" cy="8356049"/>
            </a:xfrm>
            <a:prstGeom prst="rect">
              <a:avLst/>
            </a:prstGeom>
          </p:spPr>
        </p:pic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3C5DAF72-80C4-894E-A754-86FBDC629C4C}"/>
                </a:ext>
              </a:extLst>
            </p:cNvPr>
            <p:cNvSpPr/>
            <p:nvPr/>
          </p:nvSpPr>
          <p:spPr>
            <a:xfrm rot="2627537">
              <a:off x="4937294" y="5792519"/>
              <a:ext cx="425716" cy="518645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zh-CN" altLang="en-US"/>
            </a:p>
          </p:txBody>
        </p:sp>
      </p:grpSp>
      <p:sp>
        <p:nvSpPr>
          <p:cNvPr id="38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085506" y="8694320"/>
            <a:ext cx="58080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7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SHR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10999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7A79E07E-96B7-AC45-8DC0-2F128363B4FC}"/>
              </a:ext>
            </a:extLst>
          </p:cNvPr>
          <p:cNvGrpSpPr/>
          <p:nvPr/>
        </p:nvGrpSpPr>
        <p:grpSpPr>
          <a:xfrm>
            <a:off x="1000730" y="1393430"/>
            <a:ext cx="2537784" cy="5190493"/>
            <a:chOff x="1851343" y="1128291"/>
            <a:chExt cx="2537784" cy="5190493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89FC0F6-EB0A-B545-B404-3D63F064C9F1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A9319A8D-E0B8-EC42-9C67-C5DDC1AF0A33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71B8D8B4-7E36-1A4B-89E0-27A7A9F45B2B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635D2838-5B6C-1A42-920C-8F106842A3F6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54D8525-D357-C145-B992-6453502FC587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4F32B6F5-6808-0549-B05B-90AAD217280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66910747-0C11-F146-B0ED-1E732D78458A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B58DD3C2-500A-4640-A2B9-CD8CA78085A2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56CFBB55-9934-9E4E-B05D-1F75FF3152A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C083FC57-E856-E041-BAF0-3CAFBC5DF4E5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96DE324D-69E6-E547-BDF6-FE65BA3BA311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5F82FD33-2959-4D46-907E-CC841BC3CE3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0C6CB4A0-CAF2-274F-9CB2-BF0F408AF29E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1B27A928-A57E-AA4A-AC79-CBF5E6D11596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6CC67B24-AFDB-7F48-BE34-C01C65ACB8C9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5BAA2274-0543-ED49-AD20-1149701D93BB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4B5FF10D-9EBE-1441-B002-AD07DA95236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496349BD-68B0-024A-BFD3-25068BF4AEDE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81BAB65A-01AF-884E-B86B-71D71F0CBD0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FE614BB-C6B5-C44E-8BF8-B6CF38933182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2405186-AE02-7F4A-82BD-864806DFDCAA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9812C4F8-DD99-6544-A38C-A546F43788F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587449A3-34A1-1445-B17E-01678B633552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9829C990-8849-B743-851C-2A6D67593AC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9E3DD844-4142-D148-933B-EBB89F120BE1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75D2690D-07A5-CD44-B4F7-15144DF38C7C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12549D0A-70A7-9345-8A68-5628DA8B49E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9FEBA240-E0C2-FE4C-97DF-3EC770B4BB3E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262A85F9-E3F8-9841-B2C2-962F4218D6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6311B131-6BCA-5D4F-A9AA-64160B0205FC}"/>
              </a:ext>
            </a:extLst>
          </p:cNvPr>
          <p:cNvGrpSpPr/>
          <p:nvPr/>
        </p:nvGrpSpPr>
        <p:grpSpPr>
          <a:xfrm>
            <a:off x="3767653" y="560443"/>
            <a:ext cx="7806735" cy="6858000"/>
            <a:chOff x="2497433" y="1371600"/>
            <a:chExt cx="7806735" cy="685800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FC30C36-3F05-654B-B007-1B18ED59D8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497433" y="1371600"/>
              <a:ext cx="7806735" cy="6858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38A3BA70-7B6F-3047-B95B-73B1A89D06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t="17301"/>
            <a:stretch/>
          </p:blipFill>
          <p:spPr>
            <a:xfrm>
              <a:off x="4551363" y="5429250"/>
              <a:ext cx="2413000" cy="346591"/>
            </a:xfrm>
            <a:prstGeom prst="rect">
              <a:avLst/>
            </a:prstGeom>
          </p:spPr>
        </p:pic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90EC1848-2FBF-394B-8E94-1AE405A3CF2C}"/>
                </a:ext>
              </a:extLst>
            </p:cNvPr>
            <p:cNvSpPr/>
            <p:nvPr/>
          </p:nvSpPr>
          <p:spPr>
            <a:xfrm>
              <a:off x="8199864" y="5274527"/>
              <a:ext cx="479503" cy="501313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zh-CN" altLang="en-US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93C213A-BDD8-E14E-9F81-F94624533FF3}"/>
                </a:ext>
              </a:extLst>
            </p:cNvPr>
            <p:cNvSpPr txBox="1"/>
            <p:nvPr/>
          </p:nvSpPr>
          <p:spPr>
            <a:xfrm>
              <a:off x="6676636" y="5374794"/>
              <a:ext cx="8515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PIRs</a:t>
              </a:r>
            </a:p>
          </p:txBody>
        </p:sp>
      </p:grpSp>
      <p:sp>
        <p:nvSpPr>
          <p:cNvPr id="3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179441" y="8183657"/>
            <a:ext cx="56701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8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PIR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9593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2F5244C7-4F5F-5044-B811-E67F2267BE8C}"/>
              </a:ext>
            </a:extLst>
          </p:cNvPr>
          <p:cNvGrpSpPr/>
          <p:nvPr/>
        </p:nvGrpSpPr>
        <p:grpSpPr>
          <a:xfrm>
            <a:off x="3002606" y="-89811"/>
            <a:ext cx="8677787" cy="8757147"/>
            <a:chOff x="3721100" y="949327"/>
            <a:chExt cx="7318679" cy="7280272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40948CDB-A513-4648-A01A-E688BF4B47B4}"/>
                </a:ext>
              </a:extLst>
            </p:cNvPr>
            <p:cNvGrpSpPr/>
            <p:nvPr/>
          </p:nvGrpSpPr>
          <p:grpSpPr>
            <a:xfrm>
              <a:off x="3721100" y="949327"/>
              <a:ext cx="7318679" cy="7280272"/>
              <a:chOff x="2936248" y="108660"/>
              <a:chExt cx="8663784" cy="9084042"/>
            </a:xfrm>
          </p:grpSpPr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74BA4F12-2C43-4242-B3B7-931E064FDA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5717" t="14301" r="5814" b="3424"/>
              <a:stretch/>
            </p:blipFill>
            <p:spPr>
              <a:xfrm>
                <a:off x="2936248" y="108660"/>
                <a:ext cx="8663784" cy="9084042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A961212-FF4B-824C-9F8C-571E0AFEDF17}"/>
                  </a:ext>
                </a:extLst>
              </p:cNvPr>
              <p:cNvSpPr txBox="1"/>
              <p:nvPr/>
            </p:nvSpPr>
            <p:spPr>
              <a:xfrm>
                <a:off x="9149701" y="2441745"/>
                <a:ext cx="6848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PCH</a:t>
                </a:r>
                <a:endParaRPr kumimoji="1"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268146E6-D0BC-F046-B5B3-05A5A7F6DADA}"/>
                  </a:ext>
                </a:extLst>
              </p:cNvPr>
              <p:cNvSpPr txBox="1"/>
              <p:nvPr/>
            </p:nvSpPr>
            <p:spPr>
              <a:xfrm>
                <a:off x="5951660" y="1285034"/>
                <a:ext cx="673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AMA</a:t>
                </a:r>
                <a:endParaRPr kumimoji="1"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FAB5F36-D2DA-A745-AC58-3D85F54FEFC9}"/>
                  </a:ext>
                </a:extLst>
              </p:cNvPr>
              <p:cNvSpPr txBox="1"/>
              <p:nvPr/>
            </p:nvSpPr>
            <p:spPr>
              <a:xfrm>
                <a:off x="8209615" y="1592811"/>
                <a:ext cx="1128762" cy="384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UTE</a:t>
                </a:r>
                <a:endParaRPr kumimoji="1"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55DC57C2-BC34-AE47-B782-547851A22FC8}"/>
                </a:ext>
              </a:extLst>
            </p:cNvPr>
            <p:cNvSpPr txBox="1"/>
            <p:nvPr/>
          </p:nvSpPr>
          <p:spPr>
            <a:xfrm>
              <a:off x="6485498" y="4112503"/>
              <a:ext cx="703281" cy="3838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SMF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B488F5B0-EBD0-B942-AD46-718A3D330F06}"/>
              </a:ext>
            </a:extLst>
          </p:cNvPr>
          <p:cNvGrpSpPr/>
          <p:nvPr/>
        </p:nvGrpSpPr>
        <p:grpSpPr>
          <a:xfrm>
            <a:off x="721303" y="952559"/>
            <a:ext cx="2537784" cy="5190493"/>
            <a:chOff x="1851343" y="1128291"/>
            <a:chExt cx="2537784" cy="5190493"/>
          </a:xfrm>
        </p:grpSpPr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B1071D81-CE16-8A4C-A45F-49201D021EEB}"/>
                </a:ext>
              </a:extLst>
            </p:cNvPr>
            <p:cNvSpPr txBox="1"/>
            <p:nvPr/>
          </p:nvSpPr>
          <p:spPr>
            <a:xfrm>
              <a:off x="2139793" y="4466022"/>
              <a:ext cx="2249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" altLang="zh-CN" sz="1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crogymnospermae</a:t>
              </a:r>
              <a:endParaRPr kumimoji="1" lang="zh-CN" altLang="en-US" sz="1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D2097F47-1B4A-C44E-8DD4-3884AA124992}"/>
                </a:ext>
              </a:extLst>
            </p:cNvPr>
            <p:cNvGrpSpPr/>
            <p:nvPr/>
          </p:nvGrpSpPr>
          <p:grpSpPr>
            <a:xfrm>
              <a:off x="1851343" y="1128291"/>
              <a:ext cx="2281303" cy="5190493"/>
              <a:chOff x="1851343" y="1128291"/>
              <a:chExt cx="2281303" cy="5190493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3A05D36-F1F6-5740-BB9F-0DB7D9EC65CF}"/>
                  </a:ext>
                </a:extLst>
              </p:cNvPr>
              <p:cNvSpPr txBox="1"/>
              <p:nvPr/>
            </p:nvSpPr>
            <p:spPr>
              <a:xfrm>
                <a:off x="2139793" y="1128291"/>
                <a:ext cx="114646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utgroup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31F6B631-354F-D04A-9BAA-2E62B0E56EA6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51343" y="154064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F0C6F84-8652-2645-B054-90B112C0F0B6}"/>
                  </a:ext>
                </a:extLst>
              </p:cNvPr>
              <p:cNvSpPr txBox="1"/>
              <p:nvPr/>
            </p:nvSpPr>
            <p:spPr>
              <a:xfrm>
                <a:off x="2139793" y="1499150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hod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9D3337FD-D6B0-A94A-AE18-96254F18DE3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17050" t="22037" r="31781" b="22037"/>
              <a:stretch/>
            </p:blipFill>
            <p:spPr>
              <a:xfrm>
                <a:off x="1851343" y="1911710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B7E3A293-9B75-0C45-82AA-A9F9A61DDD17}"/>
                  </a:ext>
                </a:extLst>
              </p:cNvPr>
              <p:cNvSpPr txBox="1"/>
              <p:nvPr/>
            </p:nvSpPr>
            <p:spPr>
              <a:xfrm>
                <a:off x="2139793" y="1870009"/>
                <a:ext cx="14285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hlor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7E9ABF5-E9D4-B040-A418-CE49E7300CA1}"/>
                  </a:ext>
                </a:extLst>
              </p:cNvPr>
              <p:cNvSpPr txBox="1"/>
              <p:nvPr/>
            </p:nvSpPr>
            <p:spPr>
              <a:xfrm>
                <a:off x="2139793" y="2240868"/>
                <a:ext cx="1492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rep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CC4EAE2E-D8B5-E14A-9D63-8697DCFD5BA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22709" t="28980" r="28085" b="8317"/>
              <a:stretch/>
            </p:blipFill>
            <p:spPr>
              <a:xfrm>
                <a:off x="1851343" y="2653832"/>
                <a:ext cx="291600" cy="291600"/>
              </a:xfrm>
              <a:prstGeom prst="rect">
                <a:avLst/>
              </a:prstGeom>
            </p:spPr>
          </p:pic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0E78C750-408A-F847-AB1B-F83E47DF153C}"/>
                  </a:ext>
                </a:extLst>
              </p:cNvPr>
              <p:cNvSpPr txBox="1"/>
              <p:nvPr/>
            </p:nvSpPr>
            <p:spPr>
              <a:xfrm>
                <a:off x="2139793" y="2611727"/>
                <a:ext cx="19928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thocerot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BEE5B5CD-8FED-DB4B-9463-E9FDD673EF2A}"/>
                  </a:ext>
                </a:extLst>
              </p:cNvPr>
              <p:cNvSpPr txBox="1"/>
              <p:nvPr/>
            </p:nvSpPr>
            <p:spPr>
              <a:xfrm>
                <a:off x="2139793" y="2982586"/>
                <a:ext cx="1223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y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A5B9ED67-8CBC-324E-A355-9E71F6AC125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17459" t="18391" r="20838" b="18389"/>
              <a:stretch/>
            </p:blipFill>
            <p:spPr>
              <a:xfrm>
                <a:off x="1851343" y="3395954"/>
                <a:ext cx="291600" cy="291600"/>
              </a:xfrm>
              <a:prstGeom prst="rect">
                <a:avLst/>
              </a:prstGeom>
            </p:spPr>
          </p:pic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033D79F0-BCAD-784D-AED7-55EC4767FDD6}"/>
                  </a:ext>
                </a:extLst>
              </p:cNvPr>
              <p:cNvSpPr txBox="1"/>
              <p:nvPr/>
            </p:nvSpPr>
            <p:spPr>
              <a:xfrm>
                <a:off x="2139793" y="3353445"/>
                <a:ext cx="189026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chant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03A4C576-67EE-2041-BC4B-CCD0FF208FA0}"/>
                  </a:ext>
                </a:extLst>
              </p:cNvPr>
              <p:cNvSpPr txBox="1"/>
              <p:nvPr/>
            </p:nvSpPr>
            <p:spPr>
              <a:xfrm>
                <a:off x="2139793" y="3724304"/>
                <a:ext cx="17963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copodiophyt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DA5ADA9D-AACC-DA41-AD7D-DE582434E738}"/>
                  </a:ext>
                </a:extLst>
              </p:cNvPr>
              <p:cNvSpPr txBox="1"/>
              <p:nvPr/>
            </p:nvSpPr>
            <p:spPr>
              <a:xfrm>
                <a:off x="2139793" y="4095163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lypodiopsida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C79DA77C-4719-6145-BA4E-908176C5DAC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7626" t="7119" r="20034" b="21952"/>
              <a:stretch/>
            </p:blipFill>
            <p:spPr>
              <a:xfrm>
                <a:off x="1851343" y="4509137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22155FA4-0CC7-5A46-AA95-667364EA34E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16360" t="20733" r="29802" b="17392"/>
              <a:stretch/>
            </p:blipFill>
            <p:spPr>
              <a:xfrm>
                <a:off x="1851343" y="4880198"/>
                <a:ext cx="291600" cy="291600"/>
              </a:xfrm>
              <a:prstGeom prst="rect">
                <a:avLst/>
              </a:prstGeom>
            </p:spPr>
          </p:pic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A35AAF41-484E-7D40-BF6A-64ACBBC8D60D}"/>
                  </a:ext>
                </a:extLst>
              </p:cNvPr>
              <p:cNvSpPr/>
              <p:nvPr/>
            </p:nvSpPr>
            <p:spPr>
              <a:xfrm>
                <a:off x="2139793" y="4836881"/>
                <a:ext cx="114646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iliopsida</a:t>
                </a:r>
              </a:p>
            </p:txBody>
          </p:sp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210CC692-4EC4-A544-8BD3-64BE76838BB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6940" t="9174" r="30150" b="21586"/>
              <a:stretch/>
            </p:blipFill>
            <p:spPr>
              <a:xfrm>
                <a:off x="1851343" y="5251259"/>
                <a:ext cx="291600" cy="291600"/>
              </a:xfrm>
              <a:prstGeom prst="rect">
                <a:avLst/>
              </a:prstGeom>
            </p:spPr>
          </p:pic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9E9EE46D-4762-724B-B225-C40BFD1E7801}"/>
                  </a:ext>
                </a:extLst>
              </p:cNvPr>
              <p:cNvSpPr txBox="1"/>
              <p:nvPr/>
            </p:nvSpPr>
            <p:spPr>
              <a:xfrm>
                <a:off x="2139793" y="5207740"/>
                <a:ext cx="8899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ale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3BD62C4B-E20D-094A-A5CF-BA82BC26466A}"/>
                  </a:ext>
                </a:extLst>
              </p:cNvPr>
              <p:cNvSpPr txBox="1"/>
              <p:nvPr/>
            </p:nvSpPr>
            <p:spPr>
              <a:xfrm>
                <a:off x="2139793" y="5578599"/>
                <a:ext cx="12875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gnoliid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E854E52B-02E0-0744-BCF1-B376953EEE4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/>
              <a:srcRect l="16772" t="26985" r="35871" b="30327"/>
              <a:stretch/>
            </p:blipFill>
            <p:spPr>
              <a:xfrm>
                <a:off x="1851343" y="5993375"/>
                <a:ext cx="291600" cy="291600"/>
              </a:xfrm>
              <a:prstGeom prst="rect">
                <a:avLst/>
              </a:prstGeom>
            </p:spPr>
          </p:pic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28901CE2-C7DE-1B42-9731-7D10E16011F1}"/>
                  </a:ext>
                </a:extLst>
              </p:cNvPr>
              <p:cNvSpPr txBox="1"/>
              <p:nvPr/>
            </p:nvSpPr>
            <p:spPr>
              <a:xfrm>
                <a:off x="2139793" y="5949452"/>
                <a:ext cx="17491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" altLang="zh-CN" sz="1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udicotyledons</a:t>
                </a:r>
                <a:endParaRPr kumimoji="1" lang="zh-CN" altLang="en-US" sz="1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6773C358-F82A-6945-B5F3-F1B9FBF36FD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851343" y="2282771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3B1B49B2-6AE6-284E-B51A-500C33267D9D}"/>
                  </a:ext>
                </a:extLst>
              </p:cNvPr>
              <p:cNvPicPr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851343" y="3024893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3B12B419-D20E-C04D-9C83-3B7EAC985B29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51343" y="5622320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ED2719AE-372C-D54F-9588-D9E902B57A3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51343" y="3767015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E0C92AA4-48D8-C54A-8CC9-D1C38290ED4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851343" y="4138076"/>
                <a:ext cx="291600" cy="291600"/>
              </a:xfrm>
              <a:prstGeom prst="rect">
                <a:avLst/>
              </a:prstGeom>
            </p:spPr>
          </p:pic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FC5B922A-BC9E-7342-8AFA-7AD64788AB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22710" t="31501" r="41973" b="26760"/>
              <a:stretch/>
            </p:blipFill>
            <p:spPr>
              <a:xfrm>
                <a:off x="1851343" y="1169639"/>
                <a:ext cx="291549" cy="291549"/>
              </a:xfrm>
              <a:prstGeom prst="rect">
                <a:avLst/>
              </a:prstGeom>
            </p:spPr>
          </p:pic>
        </p:grpSp>
      </p:grpSp>
      <p:sp>
        <p:nvSpPr>
          <p:cNvPr id="49" name="文本框 1">
            <a:extLst>
              <a:ext uri="{FF2B5EF4-FFF2-40B4-BE49-F238E27FC236}">
                <a16:creationId xmlns:a16="http://schemas.microsoft.com/office/drawing/2014/main" id="{9E6D8F89-E433-224E-B6F2-EC0089540B9A}"/>
              </a:ext>
            </a:extLst>
          </p:cNvPr>
          <p:cNvSpPr txBox="1"/>
          <p:nvPr/>
        </p:nvSpPr>
        <p:spPr>
          <a:xfrm>
            <a:off x="3259087" y="8325979"/>
            <a:ext cx="58063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7667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75334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13002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0669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88336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26003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763670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01338" algn="l" defTabSz="1075334" rtl="0" eaLnBrk="1" latinLnBrk="0" hangingPunct="1">
              <a:defRPr sz="211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9 |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hylogenetic trees for SMFs.</a:t>
            </a:r>
            <a:r>
              <a:rPr lang="zh-CN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椭圆 49">
            <a:extLst>
              <a:ext uri="{FF2B5EF4-FFF2-40B4-BE49-F238E27FC236}">
                <a16:creationId xmlns:a16="http://schemas.microsoft.com/office/drawing/2014/main" id="{156DDF7B-E950-8140-985E-82D8CA15BFF2}"/>
              </a:ext>
            </a:extLst>
          </p:cNvPr>
          <p:cNvSpPr/>
          <p:nvPr/>
        </p:nvSpPr>
        <p:spPr>
          <a:xfrm>
            <a:off x="3844467" y="3974337"/>
            <a:ext cx="1179158" cy="501313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7890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3</TotalTime>
  <Words>233</Words>
  <Application>Microsoft Macintosh PowerPoint</Application>
  <PresentationFormat>A3 纸张(297x420 毫米)</PresentationFormat>
  <Paragraphs>163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媛媛</dc:creator>
  <cp:lastModifiedBy>王 媛媛</cp:lastModifiedBy>
  <cp:revision>34</cp:revision>
  <dcterms:created xsi:type="dcterms:W3CDTF">2020-02-10T09:10:40Z</dcterms:created>
  <dcterms:modified xsi:type="dcterms:W3CDTF">2020-04-07T01:55:35Z</dcterms:modified>
</cp:coreProperties>
</file>